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1" d="100"/>
          <a:sy n="81" d="100"/>
        </p:scale>
        <p:origin x="-1458" y="-10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617E85-3CFA-4D18-AC33-E9A646D51A37}" type="datetimeFigureOut">
              <a:rPr lang="de-CH" smtClean="0"/>
              <a:pPr/>
              <a:t>01.12.2018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500ECC-2149-4DC4-A420-83021D800718}" type="slidenum">
              <a:rPr lang="de-CH" smtClean="0"/>
              <a:pPr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xmlns="" val="37188072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617E85-3CFA-4D18-AC33-E9A646D51A37}" type="datetimeFigureOut">
              <a:rPr lang="de-CH" smtClean="0"/>
              <a:pPr/>
              <a:t>01.12.2018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500ECC-2149-4DC4-A420-83021D800718}" type="slidenum">
              <a:rPr lang="de-CH" smtClean="0"/>
              <a:pPr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xmlns="" val="15605187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617E85-3CFA-4D18-AC33-E9A646D51A37}" type="datetimeFigureOut">
              <a:rPr lang="de-CH" smtClean="0"/>
              <a:pPr/>
              <a:t>01.12.2018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500ECC-2149-4DC4-A420-83021D800718}" type="slidenum">
              <a:rPr lang="de-CH" smtClean="0"/>
              <a:pPr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xmlns="" val="35203401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617E85-3CFA-4D18-AC33-E9A646D51A37}" type="datetimeFigureOut">
              <a:rPr lang="de-CH" smtClean="0"/>
              <a:pPr/>
              <a:t>01.12.2018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500ECC-2149-4DC4-A420-83021D800718}" type="slidenum">
              <a:rPr lang="de-CH" smtClean="0"/>
              <a:pPr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xmlns="" val="35556211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617E85-3CFA-4D18-AC33-E9A646D51A37}" type="datetimeFigureOut">
              <a:rPr lang="de-CH" smtClean="0"/>
              <a:pPr/>
              <a:t>01.12.2018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500ECC-2149-4DC4-A420-83021D800718}" type="slidenum">
              <a:rPr lang="de-CH" smtClean="0"/>
              <a:pPr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xmlns="" val="31750583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617E85-3CFA-4D18-AC33-E9A646D51A37}" type="datetimeFigureOut">
              <a:rPr lang="de-CH" smtClean="0"/>
              <a:pPr/>
              <a:t>01.12.2018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500ECC-2149-4DC4-A420-83021D800718}" type="slidenum">
              <a:rPr lang="de-CH" smtClean="0"/>
              <a:pPr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xmlns="" val="9956498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617E85-3CFA-4D18-AC33-E9A646D51A37}" type="datetimeFigureOut">
              <a:rPr lang="de-CH" smtClean="0"/>
              <a:pPr/>
              <a:t>01.12.2018</a:t>
            </a:fld>
            <a:endParaRPr lang="de-CH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500ECC-2149-4DC4-A420-83021D800718}" type="slidenum">
              <a:rPr lang="de-CH" smtClean="0"/>
              <a:pPr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xmlns="" val="14762736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617E85-3CFA-4D18-AC33-E9A646D51A37}" type="datetimeFigureOut">
              <a:rPr lang="de-CH" smtClean="0"/>
              <a:pPr/>
              <a:t>01.12.2018</a:t>
            </a:fld>
            <a:endParaRPr lang="de-CH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500ECC-2149-4DC4-A420-83021D800718}" type="slidenum">
              <a:rPr lang="de-CH" smtClean="0"/>
              <a:pPr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xmlns="" val="23188444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617E85-3CFA-4D18-AC33-E9A646D51A37}" type="datetimeFigureOut">
              <a:rPr lang="de-CH" smtClean="0"/>
              <a:pPr/>
              <a:t>01.12.2018</a:t>
            </a:fld>
            <a:endParaRPr lang="de-CH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500ECC-2149-4DC4-A420-83021D800718}" type="slidenum">
              <a:rPr lang="de-CH" smtClean="0"/>
              <a:pPr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xmlns="" val="31725874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617E85-3CFA-4D18-AC33-E9A646D51A37}" type="datetimeFigureOut">
              <a:rPr lang="de-CH" smtClean="0"/>
              <a:pPr/>
              <a:t>01.12.2018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500ECC-2149-4DC4-A420-83021D800718}" type="slidenum">
              <a:rPr lang="de-CH" smtClean="0"/>
              <a:pPr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xmlns="" val="14314138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617E85-3CFA-4D18-AC33-E9A646D51A37}" type="datetimeFigureOut">
              <a:rPr lang="de-CH" smtClean="0"/>
              <a:pPr/>
              <a:t>01.12.2018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500ECC-2149-4DC4-A420-83021D800718}" type="slidenum">
              <a:rPr lang="de-CH" smtClean="0"/>
              <a:pPr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xmlns="" val="12662003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617E85-3CFA-4D18-AC33-E9A646D51A37}" type="datetimeFigureOut">
              <a:rPr lang="de-CH" smtClean="0"/>
              <a:pPr/>
              <a:t>01.12.2018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500ECC-2149-4DC4-A420-83021D800718}" type="slidenum">
              <a:rPr lang="de-CH" smtClean="0"/>
              <a:pPr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xmlns="" val="22044551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8687" y="298175"/>
            <a:ext cx="1638816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Additional file 3: </a:t>
            </a:r>
            <a:r>
              <a:rPr lang="de-CH" sz="140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de-CH" sz="1400" smtClean="0">
                <a:latin typeface="Arial" panose="020B0604020202020204" pitchFamily="34" charset="0"/>
                <a:cs typeface="Arial" panose="020B0604020202020204" pitchFamily="34" charset="0"/>
              </a:rPr>
              <a:t>S3 </a:t>
            </a:r>
            <a:endParaRPr lang="de-CH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xmlns="" id="{2284EACD-AE10-4DE2-8A98-3125C6785739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7094" b="12641"/>
          <a:stretch/>
        </p:blipFill>
        <p:spPr>
          <a:xfrm>
            <a:off x="414258" y="2196767"/>
            <a:ext cx="3055252" cy="1837262"/>
          </a:xfrm>
          <a:prstGeom prst="rect">
            <a:avLst/>
          </a:prstGeom>
        </p:spPr>
      </p:pic>
      <p:pic>
        <p:nvPicPr>
          <p:cNvPr id="5" name="Picture 4"/>
          <p:cNvPicPr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xmlns="" val="0"/>
              </a:ext>
            </a:extLst>
          </a:blip>
          <a:srcRect l="6030" b="9134"/>
          <a:stretch/>
        </p:blipFill>
        <p:spPr>
          <a:xfrm>
            <a:off x="3641551" y="2197372"/>
            <a:ext cx="3093351" cy="1911014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xmlns="" id="{6C49C5F1-DA04-46FE-97B7-678672BC4CE6}"/>
              </a:ext>
            </a:extLst>
          </p:cNvPr>
          <p:cNvSpPr txBox="1"/>
          <p:nvPr/>
        </p:nvSpPr>
        <p:spPr>
          <a:xfrm rot="16200000">
            <a:off x="-354703" y="2928102"/>
            <a:ext cx="137088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-Log10 (adjust p-value)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xmlns="" id="{F28B79A6-6BD8-4C3F-AE31-CCCB86E6AE22}"/>
              </a:ext>
            </a:extLst>
          </p:cNvPr>
          <p:cNvSpPr txBox="1"/>
          <p:nvPr/>
        </p:nvSpPr>
        <p:spPr>
          <a:xfrm>
            <a:off x="1015561" y="4053863"/>
            <a:ext cx="217880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Log2 Fold Change (transferrin / EGFR)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xmlns="" id="{F28B79A6-6BD8-4C3F-AE31-CCCB86E6AE22}"/>
              </a:ext>
            </a:extLst>
          </p:cNvPr>
          <p:cNvSpPr txBox="1"/>
          <p:nvPr/>
        </p:nvSpPr>
        <p:spPr>
          <a:xfrm>
            <a:off x="4266116" y="4053863"/>
            <a:ext cx="218521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Log2 Fold Change (insulin / transferrin)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xmlns="" id="{6C49C5F1-DA04-46FE-97B7-678672BC4CE6}"/>
              </a:ext>
            </a:extLst>
          </p:cNvPr>
          <p:cNvSpPr txBox="1"/>
          <p:nvPr/>
        </p:nvSpPr>
        <p:spPr>
          <a:xfrm rot="16200000">
            <a:off x="2893242" y="2928102"/>
            <a:ext cx="137088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-Log10 (adjust p-value)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13071201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34</Words>
  <Application>Microsoft Office PowerPoint</Application>
  <PresentationFormat>On-screen Show (4:3)</PresentationFormat>
  <Paragraphs>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vlou Maria</dc:creator>
  <cp:lastModifiedBy>0012761</cp:lastModifiedBy>
  <cp:revision>6</cp:revision>
  <dcterms:created xsi:type="dcterms:W3CDTF">2018-10-26T13:52:24Z</dcterms:created>
  <dcterms:modified xsi:type="dcterms:W3CDTF">2018-12-01T04:12:24Z</dcterms:modified>
</cp:coreProperties>
</file>